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4662"/>
  </p:normalViewPr>
  <p:slideViewPr>
    <p:cSldViewPr snapToGrid="0" snapToObjects="1">
      <p:cViewPr varScale="1">
        <p:scale>
          <a:sx n="95" d="100"/>
          <a:sy n="95" d="100"/>
        </p:scale>
        <p:origin x="22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klaudiaszymczak\Documents\AstraZeneca%20colaboration\Chemotaxis%20PMN%20d7%205e4%20cells_fbs%20vs%20fbs%20w%20kc%20at%2010.50.%20100.150.200ngml_plus%20stand%20curve_cell%20titer_10.1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klaudiaszymczak\Documents\AstraZeneca%20colaboration\Chemotaxis%20PMN%20d7%202e4,%205e4%20and%201e5%20cells_fbs%20vs%20fbs%20w%20kc_plus%20stand%20curve_cell%20titer_9.28.18%20k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klaudiaszymczak\Desktop\chemotaxis%20d7%20PMN%20with%20RIST%2020%2015%2010%205%202%201%200.5%20nM%202e5%20cells%207.18.19%20k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837888365153179"/>
          <c:y val="5.3367041201191026E-2"/>
          <c:w val="0.73229035545412591"/>
          <c:h val="0.71885642157140794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88500"/>
                </a:schemeClr>
              </a:solidFill>
              <a:ln w="9525">
                <a:solidFill>
                  <a:schemeClr val="dk1">
                    <a:tint val="88500"/>
                  </a:schemeClr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dk1">
                    <a:tint val="885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2.8248265941373352E-2"/>
                  <c:y val="4.0031070398820062E-3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000" b="0" i="0" u="none" strike="noStrike" kern="120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Plate 1 - Sheet1'!$O$51:$R$51</c:f>
              <c:numCache>
                <c:formatCode>General</c:formatCode>
                <c:ptCount val="4"/>
                <c:pt idx="0">
                  <c:v>0</c:v>
                </c:pt>
                <c:pt idx="1">
                  <c:v>10000</c:v>
                </c:pt>
                <c:pt idx="2">
                  <c:v>20000</c:v>
                </c:pt>
                <c:pt idx="3">
                  <c:v>50000</c:v>
                </c:pt>
              </c:numCache>
            </c:numRef>
          </c:xVal>
          <c:yVal>
            <c:numRef>
              <c:f>'Plate 1 - Sheet1'!$O$52:$R$52</c:f>
              <c:numCache>
                <c:formatCode>General</c:formatCode>
                <c:ptCount val="4"/>
                <c:pt idx="0">
                  <c:v>558.33000000000004</c:v>
                </c:pt>
                <c:pt idx="1">
                  <c:v>31030.333333333332</c:v>
                </c:pt>
                <c:pt idx="2">
                  <c:v>68046.666666666672</c:v>
                </c:pt>
                <c:pt idx="3">
                  <c:v>122298.3333333333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54C2-6449-BA79-E34CA42E936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28697711"/>
        <c:axId val="182267967"/>
      </c:scatterChart>
      <c:valAx>
        <c:axId val="22869771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ell</a:t>
                </a:r>
                <a:r>
                  <a:rPr lang="en-US" sz="1200" b="1" baseline="0" dirty="0">
                    <a:latin typeface="Arial" panose="020B0604020202020204" pitchFamily="34" charset="0"/>
                    <a:cs typeface="Arial" panose="020B0604020202020204" pitchFamily="34" charset="0"/>
                  </a:rPr>
                  <a:t> number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46142200299239611"/>
              <c:y val="0.8941863979993552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2267967"/>
        <c:crosses val="autoZero"/>
        <c:crossBetween val="midCat"/>
      </c:valAx>
      <c:valAx>
        <c:axId val="18226796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Light Units</a:t>
                </a:r>
              </a:p>
            </c:rich>
          </c:tx>
          <c:layout>
            <c:manualLayout>
              <c:xMode val="edge"/>
              <c:yMode val="edge"/>
              <c:x val="2.7006170378313918E-2"/>
              <c:y val="0.1226321144267711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28697711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891962040270589"/>
          <c:y val="5.3175186868282188E-2"/>
          <c:w val="0.7036577066828954"/>
          <c:h val="0.71986713178649508"/>
        </c:manualLayout>
      </c:layout>
      <c:scatterChart>
        <c:scatterStyle val="lineMarker"/>
        <c:varyColors val="0"/>
        <c:ser>
          <c:idx val="0"/>
          <c:order val="0"/>
          <c:spPr>
            <a:ln w="317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3.414808412033131E-2"/>
                  <c:y val="-4.008440772964598E-3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000" b="0" i="0" u="none" strike="noStrike" kern="120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Plate 1 - Sheet1'!$M$51:$P$51</c:f>
              <c:numCache>
                <c:formatCode>General</c:formatCode>
                <c:ptCount val="4"/>
                <c:pt idx="0">
                  <c:v>0</c:v>
                </c:pt>
                <c:pt idx="1">
                  <c:v>20000</c:v>
                </c:pt>
                <c:pt idx="2">
                  <c:v>50000</c:v>
                </c:pt>
                <c:pt idx="3">
                  <c:v>100000</c:v>
                </c:pt>
              </c:numCache>
            </c:numRef>
          </c:xVal>
          <c:yVal>
            <c:numRef>
              <c:f>'Plate 1 - Sheet1'!$M$52:$P$52</c:f>
              <c:numCache>
                <c:formatCode>General</c:formatCode>
                <c:ptCount val="4"/>
                <c:pt idx="0">
                  <c:v>788.66666666666697</c:v>
                </c:pt>
                <c:pt idx="1">
                  <c:v>61593</c:v>
                </c:pt>
                <c:pt idx="2">
                  <c:v>165717.5</c:v>
                </c:pt>
                <c:pt idx="3">
                  <c:v>296320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325-2D44-BD4B-EC54B28C520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628292112"/>
        <c:axId val="-628293888"/>
      </c:scatterChart>
      <c:valAx>
        <c:axId val="-62829211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ell number</a:t>
                </a:r>
              </a:p>
            </c:rich>
          </c:tx>
          <c:layout>
            <c:manualLayout>
              <c:xMode val="edge"/>
              <c:yMode val="edge"/>
              <c:x val="0.46017248428591329"/>
              <c:y val="0.8897255354219848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28293888"/>
        <c:crosses val="autoZero"/>
        <c:crossBetween val="midCat"/>
        <c:majorUnit val="20000"/>
        <c:minorUnit val="2000"/>
      </c:valAx>
      <c:valAx>
        <c:axId val="-62829388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Light Units</a:t>
                </a:r>
              </a:p>
            </c:rich>
          </c:tx>
          <c:layout>
            <c:manualLayout>
              <c:xMode val="edge"/>
              <c:yMode val="edge"/>
              <c:x val="2.4249116012418508E-2"/>
              <c:y val="0.1239082657020867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2829211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Plate 1 - Sheet1'!$C$47</c:f>
              <c:strCache>
                <c:ptCount val="1"/>
                <c:pt idx="0">
                  <c:v>FB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late 1 - Sheet1'!$E$48:$E$53</c:f>
                <c:numCache>
                  <c:formatCode>General</c:formatCode>
                  <c:ptCount val="6"/>
                  <c:pt idx="0">
                    <c:v>912.73051882798359</c:v>
                  </c:pt>
                  <c:pt idx="1">
                    <c:v>742.35054612584031</c:v>
                  </c:pt>
                  <c:pt idx="2">
                    <c:v>761.52763136562112</c:v>
                  </c:pt>
                  <c:pt idx="3">
                    <c:v>1294.3358657370711</c:v>
                  </c:pt>
                  <c:pt idx="4">
                    <c:v>1914.8167014103465</c:v>
                  </c:pt>
                  <c:pt idx="5">
                    <c:v>933.47540585348759</c:v>
                  </c:pt>
                </c:numCache>
              </c:numRef>
            </c:plus>
            <c:minus>
              <c:numRef>
                <c:f>'Plate 1 - Sheet1'!$E$48:$E$53</c:f>
                <c:numCache>
                  <c:formatCode>General</c:formatCode>
                  <c:ptCount val="6"/>
                  <c:pt idx="0">
                    <c:v>912.73051882798359</c:v>
                  </c:pt>
                  <c:pt idx="1">
                    <c:v>742.35054612584031</c:v>
                  </c:pt>
                  <c:pt idx="2">
                    <c:v>761.52763136562112</c:v>
                  </c:pt>
                  <c:pt idx="3">
                    <c:v>1294.3358657370711</c:v>
                  </c:pt>
                  <c:pt idx="4">
                    <c:v>1914.8167014103465</c:v>
                  </c:pt>
                  <c:pt idx="5">
                    <c:v>933.4754058534875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Plate 1 - Sheet1'!$B$48:$B$53</c:f>
              <c:strCache>
                <c:ptCount val="6"/>
                <c:pt idx="0">
                  <c:v>DMSO</c:v>
                </c:pt>
                <c:pt idx="1">
                  <c:v>1nM</c:v>
                </c:pt>
                <c:pt idx="2">
                  <c:v>5nM</c:v>
                </c:pt>
                <c:pt idx="3">
                  <c:v>10nM</c:v>
                </c:pt>
                <c:pt idx="4">
                  <c:v>15nM</c:v>
                </c:pt>
                <c:pt idx="5">
                  <c:v>20nM</c:v>
                </c:pt>
              </c:strCache>
            </c:strRef>
          </c:cat>
          <c:val>
            <c:numRef>
              <c:f>'Plate 1 - Sheet1'!$C$48:$C$53</c:f>
              <c:numCache>
                <c:formatCode>General</c:formatCode>
                <c:ptCount val="6"/>
                <c:pt idx="0">
                  <c:v>14128.67</c:v>
                </c:pt>
                <c:pt idx="1">
                  <c:v>17393.00333333333</c:v>
                </c:pt>
                <c:pt idx="2">
                  <c:v>15579.003333333334</c:v>
                </c:pt>
                <c:pt idx="3">
                  <c:v>14143.003333333334</c:v>
                </c:pt>
                <c:pt idx="4">
                  <c:v>13679.67</c:v>
                </c:pt>
                <c:pt idx="5">
                  <c:v>13328.3366666666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40C-41E9-B3F2-E3868A5A758A}"/>
            </c:ext>
          </c:extLst>
        </c:ser>
        <c:ser>
          <c:idx val="1"/>
          <c:order val="1"/>
          <c:tx>
            <c:strRef>
              <c:f>'Plate 1 - Sheet1'!$D$47</c:f>
              <c:strCache>
                <c:ptCount val="1"/>
                <c:pt idx="0">
                  <c:v>FBS+KC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late 1 - Sheet1'!$F$48:$F$53</c:f>
                <c:numCache>
                  <c:formatCode>General</c:formatCode>
                  <c:ptCount val="6"/>
                  <c:pt idx="0">
                    <c:v>2779.4028735203779</c:v>
                  </c:pt>
                  <c:pt idx="1">
                    <c:v>6573.5489146528253</c:v>
                  </c:pt>
                  <c:pt idx="2">
                    <c:v>6316.4769716459296</c:v>
                  </c:pt>
                  <c:pt idx="3">
                    <c:v>271.71737768006915</c:v>
                  </c:pt>
                  <c:pt idx="4">
                    <c:v>2272.3418170102259</c:v>
                  </c:pt>
                  <c:pt idx="5">
                    <c:v>4203.3372852215107</c:v>
                  </c:pt>
                </c:numCache>
              </c:numRef>
            </c:plus>
            <c:minus>
              <c:numRef>
                <c:f>'Plate 1 - Sheet1'!$F$48:$F$53</c:f>
                <c:numCache>
                  <c:formatCode>General</c:formatCode>
                  <c:ptCount val="6"/>
                  <c:pt idx="0">
                    <c:v>2779.4028735203779</c:v>
                  </c:pt>
                  <c:pt idx="1">
                    <c:v>6573.5489146528253</c:v>
                  </c:pt>
                  <c:pt idx="2">
                    <c:v>6316.4769716459296</c:v>
                  </c:pt>
                  <c:pt idx="3">
                    <c:v>271.71737768006915</c:v>
                  </c:pt>
                  <c:pt idx="4">
                    <c:v>2272.3418170102259</c:v>
                  </c:pt>
                  <c:pt idx="5">
                    <c:v>4203.337285221510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Plate 1 - Sheet1'!$B$48:$B$53</c:f>
              <c:strCache>
                <c:ptCount val="6"/>
                <c:pt idx="0">
                  <c:v>DMSO</c:v>
                </c:pt>
                <c:pt idx="1">
                  <c:v>1nM</c:v>
                </c:pt>
                <c:pt idx="2">
                  <c:v>5nM</c:v>
                </c:pt>
                <c:pt idx="3">
                  <c:v>10nM</c:v>
                </c:pt>
                <c:pt idx="4">
                  <c:v>15nM</c:v>
                </c:pt>
                <c:pt idx="5">
                  <c:v>20nM</c:v>
                </c:pt>
              </c:strCache>
            </c:strRef>
          </c:cat>
          <c:val>
            <c:numRef>
              <c:f>'Plate 1 - Sheet1'!$D$48:$D$53</c:f>
              <c:numCache>
                <c:formatCode>General</c:formatCode>
                <c:ptCount val="6"/>
                <c:pt idx="0">
                  <c:v>91653.33666666667</c:v>
                </c:pt>
                <c:pt idx="1">
                  <c:v>95254.003333333341</c:v>
                </c:pt>
                <c:pt idx="2">
                  <c:v>83043.33666666667</c:v>
                </c:pt>
                <c:pt idx="3">
                  <c:v>68298.33666666667</c:v>
                </c:pt>
                <c:pt idx="4">
                  <c:v>60215.33666666667</c:v>
                </c:pt>
                <c:pt idx="5">
                  <c:v>49593.6700000000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40C-41E9-B3F2-E3868A5A758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24"/>
        <c:overlap val="-27"/>
        <c:axId val="1890430239"/>
        <c:axId val="1890251279"/>
      </c:barChart>
      <c:catAx>
        <c:axId val="189043023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90251279"/>
        <c:crosses val="autoZero"/>
        <c:auto val="1"/>
        <c:lblAlgn val="ctr"/>
        <c:lblOffset val="100"/>
        <c:noMultiLvlLbl val="0"/>
      </c:catAx>
      <c:valAx>
        <c:axId val="1890251279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 dirty="0"/>
                  <a:t>Relative</a:t>
                </a:r>
                <a:r>
                  <a:rPr lang="en-US" sz="1200" b="1" baseline="0" dirty="0"/>
                  <a:t> light units</a:t>
                </a:r>
                <a:endParaRPr lang="en-US" sz="1200" b="1" dirty="0"/>
              </a:p>
            </c:rich>
          </c:tx>
          <c:layout>
            <c:manualLayout>
              <c:xMode val="edge"/>
              <c:yMode val="edge"/>
              <c:x val="2.5291829654769844E-2"/>
              <c:y val="0.1307602163345707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#,##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9043023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D85043-14A6-7F42-A230-ED11137375E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4DCC304-D622-A240-A0B0-368B5E362AB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BE976F-999F-CA4D-8C51-3B38B76908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0798-6B88-E241-819F-2D8ADE767CD8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6C3FA1-AA8F-194C-B560-F14A649F8A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744948-3A71-4241-BBB9-554848A5D3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F0A20-39A8-134E-80B5-29F36BC31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3032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8A93EC-BEE9-3D47-AA5B-D34DD69A49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071F4D7-0048-8B46-91F6-730744060AF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3CD44F-61CD-6940-97A5-A64FE201BA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0798-6B88-E241-819F-2D8ADE767CD8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D8A1B3-968B-FD46-9431-D757F2A9EC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FEB717-07E8-6348-BBC1-A3D0D8E79D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F0A20-39A8-134E-80B5-29F36BC31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79250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D35C286-5A9F-6A4D-8016-CA20A140B6E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876ABB-3D08-C743-8120-825D830349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C9F09B-C5A6-D446-A0D6-A7B1372CB3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0798-6B88-E241-819F-2D8ADE767CD8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368BD1-DA4D-6843-B930-21FDD74A64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8B6974-E140-2B4E-B251-3AA97463CD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F0A20-39A8-134E-80B5-29F36BC31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11923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9B0CA9-4F0A-4343-84C7-F82C5F1004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93EAE4-0FB3-364A-A86A-16DEE54E484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8FF9E8-6485-414C-A286-957CDAFF72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0798-6B88-E241-819F-2D8ADE767CD8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808DB1-7F7F-C746-B70F-26E3E2A3B9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5B47DE-3DD7-0347-8EEE-0447793C16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F0A20-39A8-134E-80B5-29F36BC31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50175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D759AA-5525-F341-B426-10D1DB5E02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30FD70-B031-6B42-AB65-2D7ADBC3B0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8ED6B9-6A25-CF4D-82B5-3CA1106C1D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0798-6B88-E241-819F-2D8ADE767CD8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1A2D10-1E85-D843-ACE9-1D179CF35A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9E3143-23AB-D148-A455-06BF062CD0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F0A20-39A8-134E-80B5-29F36BC31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07685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5DC9E1-1131-8F45-8830-6A38B8051E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0E0F88A-75D2-F94F-A2FD-088165B5E88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BDECE8B-F20C-964C-8795-444BC59670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2DB9E9-580B-B647-A6BC-C637B6152F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0798-6B88-E241-819F-2D8ADE767CD8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D641476-D434-734A-891F-5F8E908787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1BD374A-0BC7-6E4B-9949-CC20096725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F0A20-39A8-134E-80B5-29F36BC31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7643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317761-1DD3-8242-8DAB-81B90E9276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9E62423-0EE8-C449-A9BC-5926AD30C7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DD114BD-342E-D244-A72C-F2F728E497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8772C86-974D-D145-A6CA-1A0462A0880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54DFDB6-C447-004A-83A2-889621B4974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8690054-B7BE-3A4B-8B61-01CE72F84D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0798-6B88-E241-819F-2D8ADE767CD8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838D723-0291-DF47-9E04-5F22E503AB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F8C774D-DBAC-6840-A7AE-A0DD8A0AB1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F0A20-39A8-134E-80B5-29F36BC31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2290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9D6BF0-E2E4-D041-B105-D7F324BE1F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2247538-7A6B-F544-B570-B0BBCF5862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0798-6B88-E241-819F-2D8ADE767CD8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20FE7C2-2FE8-7D42-B260-207D77CEEF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094F3EB-EC45-C34F-8C77-F974531956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F0A20-39A8-134E-80B5-29F36BC31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8037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C19EB2B-1685-4F46-896B-14C6DB76F0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0798-6B88-E241-819F-2D8ADE767CD8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1202C63-D33B-2541-997B-E5323025C2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2023040-36B9-5E43-889A-D8AF5A9155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F0A20-39A8-134E-80B5-29F36BC31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20729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624660-64BC-6F4E-A875-60F4C0260B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014C8D-7B31-E847-A0A3-271BFF7680F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8B6DE78-F467-1A41-BF8C-01A3D8E552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0013EA0-EC5B-C54E-B150-54F309CDA9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0798-6B88-E241-819F-2D8ADE767CD8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1FA8649-F815-034A-8B4D-1185D0AEB5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39A9408-AAE6-C345-9F0B-2675DA5C4F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F0A20-39A8-134E-80B5-29F36BC31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8715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60A59B-C650-9843-BB92-3CF0A70999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7B989A2-2018-E945-80A6-419090C1B13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6212A1E-F0DF-3146-833C-4B13C9D6DD8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ED19DCE-9CE0-1949-9621-4A1C95FCF9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0798-6B88-E241-819F-2D8ADE767CD8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CDCBD64-00FF-554F-8CF5-BAEE3B9306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AA2D11-F75B-EA4E-BC03-3AC58396FB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F0A20-39A8-134E-80B5-29F36BC31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60434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3F8D84E-577B-8F40-A13D-1646C404EC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5B674B-A6C1-094F-ACFC-C477D81A39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F21320-0AAD-754C-BE33-7097E84A403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BE0798-6B88-E241-819F-2D8ADE767CD8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586D8D-B37E-374E-948E-865024F1CDA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DACF0E-F554-E046-A74F-753C541B405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3F0A20-39A8-134E-80B5-29F36BC31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31827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917155A3-1C8D-D149-9280-3307C8DADC7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58155819"/>
              </p:ext>
            </p:extLst>
          </p:nvPr>
        </p:nvGraphicFramePr>
        <p:xfrm>
          <a:off x="1125415" y="1836739"/>
          <a:ext cx="4856351" cy="27855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00000000-0008-0000-00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944327"/>
              </p:ext>
            </p:extLst>
          </p:nvPr>
        </p:nvGraphicFramePr>
        <p:xfrm>
          <a:off x="5981767" y="1826689"/>
          <a:ext cx="5087286" cy="27955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0" y="6545818"/>
            <a:ext cx="40655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iomedicines 2172562 Supplemental Figure S1 </a:t>
            </a:r>
          </a:p>
        </p:txBody>
      </p:sp>
    </p:spTree>
    <p:extLst>
      <p:ext uri="{BB962C8B-B14F-4D97-AF65-F5344CB8AC3E}">
        <p14:creationId xmlns:p14="http://schemas.microsoft.com/office/powerpoint/2010/main" val="36365598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B1504578-1540-BB4F-8134-DC8948A75BE9}"/>
              </a:ext>
            </a:extLst>
          </p:cNvPr>
          <p:cNvGraphicFramePr>
            <a:graphicFrameLocks/>
          </p:cNvGraphicFramePr>
          <p:nvPr/>
        </p:nvGraphicFramePr>
        <p:xfrm>
          <a:off x="3388061" y="1950644"/>
          <a:ext cx="4519246" cy="25941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FDB30646-CBF6-E947-93EF-8A9E27F2BD55}"/>
              </a:ext>
            </a:extLst>
          </p:cNvPr>
          <p:cNvCxnSpPr>
            <a:cxnSpLocks/>
          </p:cNvCxnSpPr>
          <p:nvPr/>
        </p:nvCxnSpPr>
        <p:spPr>
          <a:xfrm>
            <a:off x="4814858" y="2095064"/>
            <a:ext cx="166172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4923927" y="4543785"/>
            <a:ext cx="276752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5812200" y="4549499"/>
            <a:ext cx="9909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IST4721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FDB30646-CBF6-E947-93EF-8A9E27F2BD55}"/>
              </a:ext>
            </a:extLst>
          </p:cNvPr>
          <p:cNvCxnSpPr>
            <a:cxnSpLocks/>
          </p:cNvCxnSpPr>
          <p:nvPr/>
        </p:nvCxnSpPr>
        <p:spPr>
          <a:xfrm>
            <a:off x="4814858" y="2315299"/>
            <a:ext cx="111562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5120400" y="2102082"/>
            <a:ext cx="6479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 = 0.06</a:t>
            </a:r>
          </a:p>
        </p:txBody>
      </p:sp>
      <p:grpSp>
        <p:nvGrpSpPr>
          <p:cNvPr id="43" name="Group 42"/>
          <p:cNvGrpSpPr/>
          <p:nvPr/>
        </p:nvGrpSpPr>
        <p:grpSpPr>
          <a:xfrm>
            <a:off x="6734938" y="2109962"/>
            <a:ext cx="1098428" cy="487967"/>
            <a:chOff x="7299960" y="731165"/>
            <a:chExt cx="1098428" cy="487967"/>
          </a:xfrm>
        </p:grpSpPr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09E0ED65-6555-474F-AFBE-C099729BFE3E}"/>
                </a:ext>
              </a:extLst>
            </p:cNvPr>
            <p:cNvSpPr/>
            <p:nvPr/>
          </p:nvSpPr>
          <p:spPr>
            <a:xfrm>
              <a:off x="7423506" y="822446"/>
              <a:ext cx="109727" cy="109727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 sz="2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E51B749A-BFE7-D84B-A1ED-A77F46F1D8B8}"/>
                </a:ext>
              </a:extLst>
            </p:cNvPr>
            <p:cNvSpPr/>
            <p:nvPr/>
          </p:nvSpPr>
          <p:spPr>
            <a:xfrm>
              <a:off x="7423506" y="1019560"/>
              <a:ext cx="109727" cy="109727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97">
              <a:extLst>
                <a:ext uri="{FF2B5EF4-FFF2-40B4-BE49-F238E27FC236}">
                  <a16:creationId xmlns:a16="http://schemas.microsoft.com/office/drawing/2014/main" id="{1486754B-880E-4448-B868-39792734DC5C}"/>
                </a:ext>
              </a:extLst>
            </p:cNvPr>
            <p:cNvSpPr txBox="1"/>
            <p:nvPr/>
          </p:nvSpPr>
          <p:spPr>
            <a:xfrm>
              <a:off x="7513934" y="751411"/>
              <a:ext cx="437695" cy="21809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sz="1001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FBS</a:t>
              </a:r>
              <a:endPara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98">
              <a:extLst>
                <a:ext uri="{FF2B5EF4-FFF2-40B4-BE49-F238E27FC236}">
                  <a16:creationId xmlns:a16="http://schemas.microsoft.com/office/drawing/2014/main" id="{AD440F62-1287-E146-9289-72782EDCE12C}"/>
                </a:ext>
              </a:extLst>
            </p:cNvPr>
            <p:cNvSpPr txBox="1"/>
            <p:nvPr/>
          </p:nvSpPr>
          <p:spPr>
            <a:xfrm>
              <a:off x="7518947" y="947466"/>
              <a:ext cx="879441" cy="257128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sz="1001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FBS + KC</a:t>
              </a:r>
              <a:endPara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FCE249E1-7C29-C347-B815-224A383A2D1C}"/>
                </a:ext>
              </a:extLst>
            </p:cNvPr>
            <p:cNvSpPr/>
            <p:nvPr/>
          </p:nvSpPr>
          <p:spPr>
            <a:xfrm>
              <a:off x="7299960" y="731165"/>
              <a:ext cx="949534" cy="48796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CE83EFF0-5249-A598-0350-E8EE0B0C958D}"/>
              </a:ext>
            </a:extLst>
          </p:cNvPr>
          <p:cNvSpPr txBox="1"/>
          <p:nvPr/>
        </p:nvSpPr>
        <p:spPr>
          <a:xfrm>
            <a:off x="5360121" y="1879984"/>
            <a:ext cx="7184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 &lt; 0.00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2660731-EB9C-B982-1E22-ACB4B9D21DC3}"/>
              </a:ext>
            </a:extLst>
          </p:cNvPr>
          <p:cNvSpPr txBox="1"/>
          <p:nvPr/>
        </p:nvSpPr>
        <p:spPr>
          <a:xfrm>
            <a:off x="0" y="6545818"/>
            <a:ext cx="40655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iomedicines 2172562 Supplemental </a:t>
            </a:r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Figure S2 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41252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23</TotalTime>
  <Words>34</Words>
  <Application>Microsoft Office PowerPoint</Application>
  <PresentationFormat>Widescreen</PresentationFormat>
  <Paragraphs>1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laudia</dc:creator>
  <cp:lastModifiedBy>Gaines, Peter</cp:lastModifiedBy>
  <cp:revision>17</cp:revision>
  <cp:lastPrinted>2022-05-24T15:48:21Z</cp:lastPrinted>
  <dcterms:created xsi:type="dcterms:W3CDTF">2020-02-24T18:20:52Z</dcterms:created>
  <dcterms:modified xsi:type="dcterms:W3CDTF">2023-02-03T18:28:03Z</dcterms:modified>
</cp:coreProperties>
</file>